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B3302E-697C-4D46-9938-AD3238B8B49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D35F10-6E1F-4B83-B387-C5EBCCE2DE3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A39573-7212-4586-BA3B-1E783FCE84A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ACDC96-E471-4F40-8C9B-3DFE6943432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02FC4E-8B30-405A-AE7F-CDBB4438C0B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14AE3D-4B0F-4A57-8C89-4EB177DADA4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0E1EA8-B725-453F-8092-D81A9619F2A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41CBA8-51EE-4845-9D17-037B32BC922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C1F523-DB8C-4C7B-B885-87B3FB54BBF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E3FD6E-CF3E-47D0-B655-9C4C973E421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A26318-E463-41D9-8744-4642F1062E3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5C5891-DF26-43B0-BDB1-4518E40BA38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7849FD9-58D7-424B-BEEF-9AF851C7658A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グループ化 53"/>
          <p:cNvGrpSpPr/>
          <p:nvPr/>
        </p:nvGrpSpPr>
        <p:grpSpPr>
          <a:xfrm>
            <a:off x="988200" y="468360"/>
            <a:ext cx="4516560" cy="3619080"/>
            <a:chOff x="988200" y="468360"/>
            <a:chExt cx="4516560" cy="3619080"/>
          </a:xfrm>
        </p:grpSpPr>
        <p:sp>
          <p:nvSpPr>
            <p:cNvPr id="42" name="正方形/長方形 41"/>
            <p:cNvSpPr/>
            <p:nvPr/>
          </p:nvSpPr>
          <p:spPr>
            <a:xfrm>
              <a:off x="2230200" y="2638440"/>
              <a:ext cx="2556000" cy="511200"/>
            </a:xfrm>
            <a:prstGeom prst="rect">
              <a:avLst/>
            </a:prstGeom>
            <a:solidFill>
              <a:srgbClr val="f2dcdb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" name="正方形/長方形 27"/>
            <p:cNvSpPr/>
            <p:nvPr/>
          </p:nvSpPr>
          <p:spPr>
            <a:xfrm>
              <a:off x="1046520" y="468360"/>
              <a:ext cx="290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A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" name="正方形/長方形 28"/>
            <p:cNvSpPr/>
            <p:nvPr/>
          </p:nvSpPr>
          <p:spPr>
            <a:xfrm>
              <a:off x="1057680" y="2360520"/>
              <a:ext cx="290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B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" name="テキスト ボックス 5"/>
            <p:cNvSpPr/>
            <p:nvPr/>
          </p:nvSpPr>
          <p:spPr>
            <a:xfrm>
              <a:off x="2707200" y="1550520"/>
              <a:ext cx="11271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Overlapped region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" name="正方形/長方形 21"/>
            <p:cNvSpPr/>
            <p:nvPr/>
          </p:nvSpPr>
          <p:spPr>
            <a:xfrm>
              <a:off x="1534320" y="2036880"/>
              <a:ext cx="3873240" cy="2311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0000"/>
                  </a:solidFill>
                  <a:latin typeface="Arial"/>
                  <a:ea typeface="Arial"/>
                </a:rPr>
                <a:t>MR =</a:t>
              </a:r>
              <a:r>
                <a:rPr b="0" lang="ja-JP" sz="900" spc="-1" strike="noStrike">
                  <a:solidFill>
                    <a:srgbClr val="ff0000"/>
                  </a:solidFill>
                  <a:latin typeface="Arial"/>
                  <a:ea typeface="ＭＳ 明朝"/>
                </a:rPr>
                <a:t>　</a:t>
              </a:r>
              <a:r>
                <a:rPr b="0" lang="en-US" sz="900" spc="-1" strike="noStrike">
                  <a:solidFill>
                    <a:srgbClr val="ff0000"/>
                  </a:solidFill>
                  <a:latin typeface="Arial"/>
                  <a:ea typeface="Arial"/>
                </a:rPr>
                <a:t>matched bases (40) / total bases of overlapped region (40)  = 1 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" name="テキスト ボックス 14"/>
            <p:cNvSpPr/>
            <p:nvPr/>
          </p:nvSpPr>
          <p:spPr>
            <a:xfrm>
              <a:off x="1524600" y="1806840"/>
              <a:ext cx="3731040" cy="2311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Matched bases = 40 (substitutions and insertion/deletion : 0)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" name="正方形/長方形 17"/>
            <p:cNvSpPr/>
            <p:nvPr/>
          </p:nvSpPr>
          <p:spPr>
            <a:xfrm>
              <a:off x="1608120" y="776160"/>
              <a:ext cx="3208680" cy="534960"/>
            </a:xfrm>
            <a:prstGeom prst="rect">
              <a:avLst/>
            </a:prstGeom>
            <a:solidFill>
              <a:srgbClr val="f2dcdb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" name="テキスト ボックス 1"/>
            <p:cNvSpPr/>
            <p:nvPr/>
          </p:nvSpPr>
          <p:spPr>
            <a:xfrm>
              <a:off x="1579680" y="772920"/>
              <a:ext cx="3875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ATGGCCGTCATGGCGCCCCGAACCCTCCTCCTGCTACTCTTTGGGG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" name="テキスト ボックス 29"/>
            <p:cNvSpPr/>
            <p:nvPr/>
          </p:nvSpPr>
          <p:spPr>
            <a:xfrm>
              <a:off x="1573920" y="1077840"/>
              <a:ext cx="33811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ATGGCCGTCATGGCGCCCCGAACCCTCCTCCTGCTACTCT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" name="テキスト ボックス 1"/>
            <p:cNvSpPr/>
            <p:nvPr/>
          </p:nvSpPr>
          <p:spPr>
            <a:xfrm>
              <a:off x="1554120" y="2646000"/>
              <a:ext cx="39052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TGCCGGTACATGGCGCCCCGAACCCTCCTCCTGCTACTCTCGGGGG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" name="正方形/長方形 2"/>
            <p:cNvSpPr/>
            <p:nvPr/>
          </p:nvSpPr>
          <p:spPr>
            <a:xfrm>
              <a:off x="1012320" y="2919240"/>
              <a:ext cx="5554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Query: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テキスト ボックス 5"/>
            <p:cNvSpPr/>
            <p:nvPr/>
          </p:nvSpPr>
          <p:spPr>
            <a:xfrm>
              <a:off x="2665800" y="3423600"/>
              <a:ext cx="11271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Overlapped region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テキスト ボックス 29"/>
            <p:cNvSpPr/>
            <p:nvPr/>
          </p:nvSpPr>
          <p:spPr>
            <a:xfrm>
              <a:off x="1536840" y="2918880"/>
              <a:ext cx="33811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ATGGCCGTCATGGCGCCCCGAACCCTCCTCCTGCTACTCT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右中かっこ 44"/>
            <p:cNvSpPr/>
            <p:nvPr/>
          </p:nvSpPr>
          <p:spPr>
            <a:xfrm rot="5400000">
              <a:off x="3065760" y="1680120"/>
              <a:ext cx="252360" cy="3248280"/>
            </a:xfrm>
            <a:custGeom>
              <a:avLst/>
              <a:gdLst>
                <a:gd name="textAreaLeft" fmla="*/ 0 w 252360"/>
                <a:gd name="textAreaRight" fmla="*/ 91080 w 252360"/>
                <a:gd name="textAreaTop" fmla="*/ 33120 h 3248280"/>
                <a:gd name="textAreaBottom" fmla="*/ 3215160 h 324828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5400" y="0"/>
                    <a:pt x="10800" y="354"/>
                    <a:pt x="10800" y="708"/>
                  </a:cubicBezTo>
                  <a:lnTo>
                    <a:pt x="10800" y="10092"/>
                  </a:lnTo>
                  <a:cubicBezTo>
                    <a:pt x="10800" y="10446"/>
                    <a:pt x="16200" y="10800"/>
                    <a:pt x="21600" y="10800"/>
                  </a:cubicBezTo>
                  <a:cubicBezTo>
                    <a:pt x="16200" y="10800"/>
                    <a:pt x="10800" y="11154"/>
                    <a:pt x="10800" y="11508"/>
                  </a:cubicBezTo>
                  <a:lnTo>
                    <a:pt x="10800" y="20892"/>
                  </a:lnTo>
                  <a:cubicBezTo>
                    <a:pt x="10800" y="21246"/>
                    <a:pt x="54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正方形/長方形 45"/>
            <p:cNvSpPr/>
            <p:nvPr/>
          </p:nvSpPr>
          <p:spPr>
            <a:xfrm>
              <a:off x="988200" y="2638440"/>
              <a:ext cx="5770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Target: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正方形/長方形 2"/>
            <p:cNvSpPr/>
            <p:nvPr/>
          </p:nvSpPr>
          <p:spPr>
            <a:xfrm>
              <a:off x="1012320" y="1061280"/>
              <a:ext cx="5554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Query: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正方形/長方形 47"/>
            <p:cNvSpPr/>
            <p:nvPr/>
          </p:nvSpPr>
          <p:spPr>
            <a:xfrm>
              <a:off x="1019520" y="772920"/>
              <a:ext cx="5770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Target: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右中かっこ 48"/>
            <p:cNvSpPr/>
            <p:nvPr/>
          </p:nvSpPr>
          <p:spPr>
            <a:xfrm rot="5400000">
              <a:off x="3095280" y="-147600"/>
              <a:ext cx="252360" cy="3246480"/>
            </a:xfrm>
            <a:custGeom>
              <a:avLst/>
              <a:gdLst>
                <a:gd name="textAreaLeft" fmla="*/ 0 w 252360"/>
                <a:gd name="textAreaRight" fmla="*/ 91080 w 252360"/>
                <a:gd name="textAreaTop" fmla="*/ 33120 h 3246480"/>
                <a:gd name="textAreaBottom" fmla="*/ 3213360 h 324648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5400" y="0"/>
                    <a:pt x="10800" y="355"/>
                    <a:pt x="10800" y="709"/>
                  </a:cubicBezTo>
                  <a:lnTo>
                    <a:pt x="10800" y="10091"/>
                  </a:lnTo>
                  <a:cubicBezTo>
                    <a:pt x="10800" y="10446"/>
                    <a:pt x="16200" y="10800"/>
                    <a:pt x="21600" y="10800"/>
                  </a:cubicBezTo>
                  <a:cubicBezTo>
                    <a:pt x="16200" y="10800"/>
                    <a:pt x="10800" y="11155"/>
                    <a:pt x="10800" y="11509"/>
                  </a:cubicBezTo>
                  <a:lnTo>
                    <a:pt x="10800" y="20891"/>
                  </a:lnTo>
                  <a:cubicBezTo>
                    <a:pt x="10800" y="21246"/>
                    <a:pt x="54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" name="テキスト ボックス 14"/>
            <p:cNvSpPr/>
            <p:nvPr/>
          </p:nvSpPr>
          <p:spPr>
            <a:xfrm>
              <a:off x="1524600" y="3624840"/>
              <a:ext cx="3731040" cy="2311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Matched bases = 38 (substitutions and insertion/deletion : 0)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" name="正方形/長方形 52"/>
            <p:cNvSpPr/>
            <p:nvPr/>
          </p:nvSpPr>
          <p:spPr>
            <a:xfrm>
              <a:off x="1535400" y="3856320"/>
              <a:ext cx="3969360" cy="2311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0000"/>
                  </a:solidFill>
                  <a:latin typeface="Arial"/>
                  <a:ea typeface="Arial"/>
                </a:rPr>
                <a:t>MR =</a:t>
              </a:r>
              <a:r>
                <a:rPr b="0" lang="ja-JP" sz="900" spc="-1" strike="noStrike">
                  <a:solidFill>
                    <a:srgbClr val="ff0000"/>
                  </a:solidFill>
                  <a:latin typeface="Arial"/>
                  <a:ea typeface="ＭＳ 明朝"/>
                </a:rPr>
                <a:t>　</a:t>
              </a:r>
              <a:r>
                <a:rPr b="0" lang="en-US" sz="900" spc="-1" strike="noStrike">
                  <a:solidFill>
                    <a:srgbClr val="ff0000"/>
                  </a:solidFill>
                  <a:latin typeface="Arial"/>
                  <a:ea typeface="Arial"/>
                </a:rPr>
                <a:t>matched bases (38) / total bases of overlapped region (40)  = 0.8 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62" name="テキスト ボックス 1"/>
          <p:cNvSpPr/>
          <p:nvPr/>
        </p:nvSpPr>
        <p:spPr>
          <a:xfrm>
            <a:off x="620640" y="4309920"/>
            <a:ext cx="518472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igure S1. Examples of alignment with BLAT. BLAT identifies no substitutions and  insertions/deletions in both cases. However, the bottom case have terminal unmatched sequences in the overlapping region. MR can identify this type of unmatched sequences.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03-09T08:57:13Z</dcterms:created>
  <dc:creator>h.segawa</dc:creator>
  <dc:description/>
  <dc:language>en-US</dc:language>
  <cp:lastModifiedBy>加藤 菊也</cp:lastModifiedBy>
  <dcterms:modified xsi:type="dcterms:W3CDTF">2017-06-11T06:12:43Z</dcterms:modified>
  <cp:revision>11</cp:revision>
  <dc:subject/>
  <dc:title>PowerPoint プレゼンテーション</dc:title>
</cp:coreProperties>
</file>